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7" r:id="rId2"/>
    <p:sldId id="271" r:id="rId3"/>
    <p:sldId id="272" r:id="rId4"/>
    <p:sldId id="273" r:id="rId5"/>
    <p:sldId id="274" r:id="rId6"/>
    <p:sldId id="275" r:id="rId7"/>
    <p:sldId id="276" r:id="rId8"/>
    <p:sldId id="277" r:id="rId9"/>
    <p:sldId id="278" r:id="rId10"/>
    <p:sldId id="279" r:id="rId1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33" autoAdjust="0"/>
    <p:restoredTop sz="93568" autoAdjust="0"/>
  </p:normalViewPr>
  <p:slideViewPr>
    <p:cSldViewPr>
      <p:cViewPr>
        <p:scale>
          <a:sx n="75" d="100"/>
          <a:sy n="75" d="100"/>
        </p:scale>
        <p:origin x="-1445" y="-78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171DA1-1062-46A0-AF5A-12207343DA01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DFAAEE-2527-4B91-9D49-8AF64165AE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68524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67544" y="5589240"/>
            <a:ext cx="8568952" cy="504056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henotypes of seed coat color of the two parents, F</a:t>
            </a:r>
            <a:r>
              <a:rPr lang="en-US" altLang="zh-CN" sz="12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some </a:t>
            </a:r>
            <a:r>
              <a:rPr lang="en-US" altLang="zh-CN" sz="120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sz="120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smtClean="0">
                <a:latin typeface="Times New Roman" pitchFamily="18" charset="0"/>
                <a:cs typeface="Times New Roman" pitchFamily="18" charset="0"/>
              </a:rPr>
              <a:t>progenies.</a:t>
            </a:r>
            <a:endParaRPr lang="en-US" altLang="zh-CN" sz="1200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 algn="ctr">
              <a:buNone/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Yuzh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DS899;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JS012;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zh-CN" sz="12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eeds of the cross between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Yuzh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DS899 and JS012;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eeds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ome F</a:t>
            </a:r>
            <a:r>
              <a:rPr lang="en-US" altLang="zh-CN" sz="12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rogenyies</a:t>
            </a:r>
            <a:endParaRPr lang="zh-CN" altLang="zh-CN" sz="1200" baseline="-25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E:\伯豪测序\2014-江西野芝F2\李春博士粒色图片2015.8.10\未标题-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5896" y="548680"/>
            <a:ext cx="3039170" cy="49425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E:\伯豪测序\2016.4.27群体测序\2019年粒色分析\color_LAB分布-WinCart图\亲本粒色\IMG_9816-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595" y="548680"/>
            <a:ext cx="1584177" cy="15361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E:\伯豪测序\2016.4.27群体测序\2019年粒色分析\color_LAB分布-WinCart图\亲本粒色\IMG_9805-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595" y="2253722"/>
            <a:ext cx="1584178" cy="15361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259632" y="54868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88584" y="225372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347864" y="55873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D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E:\伯豪测序\2016.4.27群体测序\2019年粒色分析\color_LAB分布-WinCart图\亲本粒色\IMG_9807-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593" y="3938183"/>
            <a:ext cx="1584179" cy="15335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259632" y="394408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C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70580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伯豪测序\2016.4.27群体测序\2019年粒色分析\论文撰写\2021\投稿Frontiers\plot-expressPattern-1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402" r="22731"/>
          <a:stretch/>
        </p:blipFill>
        <p:spPr bwMode="auto">
          <a:xfrm>
            <a:off x="580792" y="692696"/>
            <a:ext cx="6871528" cy="15841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矩形 2"/>
          <p:cNvSpPr/>
          <p:nvPr/>
        </p:nvSpPr>
        <p:spPr>
          <a:xfrm>
            <a:off x="0" y="775737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endParaRPr lang="zh-CN" altLang="en-US" dirty="0"/>
          </a:p>
        </p:txBody>
      </p:sp>
      <p:sp>
        <p:nvSpPr>
          <p:cNvPr id="4" name="内容占位符 2"/>
          <p:cNvSpPr txBox="1">
            <a:spLocks/>
          </p:cNvSpPr>
          <p:nvPr/>
        </p:nvSpPr>
        <p:spPr>
          <a:xfrm>
            <a:off x="683568" y="6148747"/>
            <a:ext cx="8136904" cy="5926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4 continue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(C):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enes with hybridized expression pattern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  <a:p>
            <a:pPr marL="0" indent="0" algn="ctr">
              <a:buNone/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9754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E:\伯豪测序\2016.4.27群体测序\2019年粒色分析\论文撰写\2021\heatmap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608" y="116630"/>
            <a:ext cx="6984776" cy="5788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内容占位符 2"/>
          <p:cNvSpPr>
            <a:spLocks noGrp="1"/>
          </p:cNvSpPr>
          <p:nvPr>
            <p:ph idx="1"/>
          </p:nvPr>
        </p:nvSpPr>
        <p:spPr>
          <a:xfrm>
            <a:off x="323528" y="6237312"/>
            <a:ext cx="8568952" cy="504056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heatmap of the sample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used fo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DEG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creening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between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white- and black-seeded varieties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0729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伯豪测序\2016.4.27群体测序\2019年粒色分析\论文撰写\2021\DE_wego_fig\JY5D_Y11C5D_Up_Dow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9144000" cy="57540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内容占位符 2"/>
          <p:cNvSpPr txBox="1">
            <a:spLocks/>
          </p:cNvSpPr>
          <p:nvPr/>
        </p:nvSpPr>
        <p:spPr>
          <a:xfrm>
            <a:off x="683568" y="5716699"/>
            <a:ext cx="8136904" cy="80992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O annotation of th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DEGs identified between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JS012 and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Yuzh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11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tag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 DAF;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0584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伯豪测序\2016.4.27群体测序\2019年粒色分析\论文撰写\2021\DE_wego_fig\JY10D_Y11C10D_Up_Dow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26" y="1042"/>
            <a:ext cx="9131573" cy="56872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内容占位符 2"/>
          <p:cNvSpPr txBox="1">
            <a:spLocks/>
          </p:cNvSpPr>
          <p:nvPr/>
        </p:nvSpPr>
        <p:spPr>
          <a:xfrm>
            <a:off x="683568" y="5788707"/>
            <a:ext cx="8136904" cy="5926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3 continue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tag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0 DAF;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96315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伯豪测序\2016.4.27群体测序\2019年粒色分析\论文撰写\2021\DE_wego_fig\JY15D_Y11C15D_Up_Dow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05" y="44624"/>
            <a:ext cx="9029049" cy="54716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内容占位符 2"/>
          <p:cNvSpPr txBox="1">
            <a:spLocks/>
          </p:cNvSpPr>
          <p:nvPr/>
        </p:nvSpPr>
        <p:spPr>
          <a:xfrm>
            <a:off x="683568" y="5788707"/>
            <a:ext cx="8136904" cy="5926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3 continue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tag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5 DAF;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76788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伯豪测序\2016.4.27群体测序\2019年粒色分析\论文撰写\2021\DE_wego_fig\JY20D_Y11C20D_Up_Dow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82" y="72008"/>
            <a:ext cx="9044397" cy="5445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内容占位符 2"/>
          <p:cNvSpPr txBox="1">
            <a:spLocks/>
          </p:cNvSpPr>
          <p:nvPr/>
        </p:nvSpPr>
        <p:spPr>
          <a:xfrm>
            <a:off x="683568" y="5788707"/>
            <a:ext cx="8136904" cy="5926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3 continue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tag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20 DAF;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3868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伯豪测序\2016.4.27群体测序\2019年粒色分析\论文撰写\2021\DE_wego_fig\JY25D_Y11C25D_Up_Dow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27384"/>
            <a:ext cx="9144000" cy="55972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内容占位符 2"/>
          <p:cNvSpPr txBox="1">
            <a:spLocks/>
          </p:cNvSpPr>
          <p:nvPr/>
        </p:nvSpPr>
        <p:spPr>
          <a:xfrm>
            <a:off x="683568" y="5788707"/>
            <a:ext cx="8136904" cy="5926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3 continue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tag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25 DAF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15617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1026" name="Picture 2" descr="E:\伯豪测序\2016.4.27群体测序\2019年粒色分析\论文撰写\2021\投稿Frontiers\plot-expressPattern-1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969"/>
          <a:stretch/>
        </p:blipFill>
        <p:spPr bwMode="auto">
          <a:xfrm>
            <a:off x="395536" y="44624"/>
            <a:ext cx="8784976" cy="564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内容占位符 2"/>
          <p:cNvSpPr txBox="1">
            <a:spLocks/>
          </p:cNvSpPr>
          <p:nvPr/>
        </p:nvSpPr>
        <p:spPr>
          <a:xfrm>
            <a:off x="683568" y="5687224"/>
            <a:ext cx="8136904" cy="105414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expression pattern of the 28 candidate genes. </a:t>
            </a:r>
          </a:p>
          <a:p>
            <a:pPr marL="0" indent="0" algn="ctr">
              <a:buNone/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x-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xis indicates the time points at 5, 10, 15, 20 and 25 DAF respectively; the y-axis indicates the expression level of the genes; *, indicates significantly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differentially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expressed; the orange lines stands for the gene expression level in JS012, while the blue line stands for in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Yuzhi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11.</a:t>
            </a:r>
          </a:p>
          <a:p>
            <a:pPr marL="0" indent="0" algn="ctr">
              <a:buNone/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A): the  gene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expressed predominantly i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JS012;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0" y="186278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017024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伯豪测序\2016.4.27群体测序\2019年粒色分析\论文撰写\2021\投稿Frontiers\plot-expressPattern-1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42" b="13304"/>
          <a:stretch/>
        </p:blipFill>
        <p:spPr bwMode="auto">
          <a:xfrm>
            <a:off x="395536" y="476672"/>
            <a:ext cx="8712968" cy="43651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内容占位符 2"/>
          <p:cNvSpPr txBox="1">
            <a:spLocks/>
          </p:cNvSpPr>
          <p:nvPr/>
        </p:nvSpPr>
        <p:spPr>
          <a:xfrm>
            <a:off x="683568" y="6148747"/>
            <a:ext cx="8136904" cy="5926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4 continue. (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B):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ene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expressed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predominantly in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Yuzhi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11;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  <a:p>
            <a:pPr marL="0" indent="0" algn="ctr">
              <a:buNone/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0" y="548680"/>
            <a:ext cx="3898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29508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4</TotalTime>
  <Words>260</Words>
  <Application>Microsoft Office PowerPoint</Application>
  <PresentationFormat>全屏显示(4:3)</PresentationFormat>
  <Paragraphs>22</Paragraphs>
  <Slides>10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1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ymentary Figures</dc:title>
  <dc:creator>docLi</dc:creator>
  <cp:lastModifiedBy>docLi</cp:lastModifiedBy>
  <cp:revision>172</cp:revision>
  <dcterms:created xsi:type="dcterms:W3CDTF">2019-06-19T01:20:12Z</dcterms:created>
  <dcterms:modified xsi:type="dcterms:W3CDTF">2021-06-30T07:30:42Z</dcterms:modified>
</cp:coreProperties>
</file>